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FF339-A0A5-4A76-8BB4-00183F8BED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9D0457-8D8A-4A8C-8654-BCC22062EE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98BCA-E022-4922-9190-064EAB23F4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5700C-05DC-4354-B78B-D639905567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9F418-357B-4D2C-A136-54CF53454C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3476C-7106-4B76-8259-0FEB4F1ADA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85FFE-2D9E-4E36-BACE-7DC0B9C0C9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92362-99C9-46EB-9900-26BF409A6C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939622-4248-4421-BCC0-EAFE6FDD86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35EC4A-9258-402C-B0D1-7A46A55F7E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42B64-4F41-4CAD-8CC8-63AF104B48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E4EC7-9376-4933-A2F4-39338C1F55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44359E-7D1C-4821-9445-E1245B0B6586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ttangolo 47"/>
          <p:cNvSpPr/>
          <p:nvPr/>
        </p:nvSpPr>
        <p:spPr>
          <a:xfrm>
            <a:off x="539640" y="260280"/>
            <a:ext cx="648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Potenza et al, S2 Fig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o 11"/>
          <p:cNvGrpSpPr/>
          <p:nvPr/>
        </p:nvGrpSpPr>
        <p:grpSpPr>
          <a:xfrm>
            <a:off x="900000" y="765000"/>
            <a:ext cx="7120800" cy="4413600"/>
            <a:chOff x="900000" y="765000"/>
            <a:chExt cx="7120800" cy="4413600"/>
          </a:xfrm>
        </p:grpSpPr>
        <p:pic>
          <p:nvPicPr>
            <p:cNvPr id="43" name="Picture 2" descr=""/>
            <p:cNvPicPr/>
            <p:nvPr/>
          </p:nvPicPr>
          <p:blipFill>
            <a:blip r:embed="rId1"/>
            <a:stretch/>
          </p:blipFill>
          <p:spPr>
            <a:xfrm>
              <a:off x="900000" y="765000"/>
              <a:ext cx="6464160" cy="4413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Parentesi graffa chiusa 3"/>
            <p:cNvSpPr/>
            <p:nvPr/>
          </p:nvSpPr>
          <p:spPr>
            <a:xfrm>
              <a:off x="6732720" y="1927080"/>
              <a:ext cx="153720" cy="718920"/>
            </a:xfrm>
            <a:custGeom>
              <a:avLst/>
              <a:gdLst>
                <a:gd name="textAreaLeft" fmla="*/ 0 w 153720"/>
                <a:gd name="textAreaRight" fmla="*/ 55440 w 153720"/>
                <a:gd name="textAreaTop" fmla="*/ 3960 h 718920"/>
                <a:gd name="textAreaBottom" fmla="*/ 714960 h 718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93"/>
                    <a:pt x="10800" y="385"/>
                  </a:cubicBezTo>
                  <a:lnTo>
                    <a:pt x="10800" y="10415"/>
                  </a:lnTo>
                  <a:cubicBezTo>
                    <a:pt x="10800" y="10608"/>
                    <a:pt x="16200" y="10800"/>
                    <a:pt x="21600" y="10800"/>
                  </a:cubicBezTo>
                  <a:cubicBezTo>
                    <a:pt x="16200" y="10800"/>
                    <a:pt x="10800" y="10993"/>
                    <a:pt x="10800" y="11185"/>
                  </a:cubicBezTo>
                  <a:lnTo>
                    <a:pt x="10800" y="21215"/>
                  </a:lnTo>
                  <a:cubicBezTo>
                    <a:pt x="10800" y="21408"/>
                    <a:pt x="5400" y="21600"/>
                    <a:pt x="0" y="21600"/>
                  </a:cubicBezTo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CasellaDiTesto 4"/>
            <p:cNvSpPr/>
            <p:nvPr/>
          </p:nvSpPr>
          <p:spPr>
            <a:xfrm>
              <a:off x="7025760" y="2085480"/>
              <a:ext cx="921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P &lt; 0.0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CasellaDiTesto 5"/>
            <p:cNvSpPr/>
            <p:nvPr/>
          </p:nvSpPr>
          <p:spPr>
            <a:xfrm>
              <a:off x="6922800" y="3594600"/>
              <a:ext cx="109800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P &lt; 0.0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CasellaDiTesto 6"/>
            <p:cNvSpPr/>
            <p:nvPr/>
          </p:nvSpPr>
          <p:spPr>
            <a:xfrm>
              <a:off x="4287240" y="1271520"/>
              <a:ext cx="3574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CasellaDiTesto 7"/>
            <p:cNvSpPr/>
            <p:nvPr/>
          </p:nvSpPr>
          <p:spPr>
            <a:xfrm>
              <a:off x="5003280" y="1290600"/>
              <a:ext cx="3574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CasellaDiTesto 8"/>
            <p:cNvSpPr/>
            <p:nvPr/>
          </p:nvSpPr>
          <p:spPr>
            <a:xfrm>
              <a:off x="6371280" y="1290600"/>
              <a:ext cx="357480" cy="5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8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2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Parentesi graffa chiusa 9"/>
            <p:cNvSpPr/>
            <p:nvPr/>
          </p:nvSpPr>
          <p:spPr>
            <a:xfrm>
              <a:off x="6516720" y="3500640"/>
              <a:ext cx="153720" cy="576000"/>
            </a:xfrm>
            <a:custGeom>
              <a:avLst/>
              <a:gdLst>
                <a:gd name="textAreaLeft" fmla="*/ 0 w 153720"/>
                <a:gd name="textAreaRight" fmla="*/ 55440 w 153720"/>
                <a:gd name="textAreaTop" fmla="*/ 3960 h 576000"/>
                <a:gd name="textAreaBottom" fmla="*/ 572040 h 576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241"/>
                    <a:pt x="10800" y="481"/>
                  </a:cubicBezTo>
                  <a:lnTo>
                    <a:pt x="10800" y="10319"/>
                  </a:lnTo>
                  <a:cubicBezTo>
                    <a:pt x="10800" y="10560"/>
                    <a:pt x="16200" y="10800"/>
                    <a:pt x="21600" y="10800"/>
                  </a:cubicBezTo>
                  <a:cubicBezTo>
                    <a:pt x="16200" y="10800"/>
                    <a:pt x="10800" y="11041"/>
                    <a:pt x="10800" y="11281"/>
                  </a:cubicBezTo>
                  <a:lnTo>
                    <a:pt x="10800" y="21119"/>
                  </a:lnTo>
                  <a:cubicBezTo>
                    <a:pt x="10800" y="21360"/>
                    <a:pt x="5400" y="21600"/>
                    <a:pt x="0" y="21600"/>
                  </a:cubicBezTo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Parentesi graffa chiusa 10"/>
            <p:cNvSpPr/>
            <p:nvPr/>
          </p:nvSpPr>
          <p:spPr>
            <a:xfrm>
              <a:off x="6669360" y="3249720"/>
              <a:ext cx="153720" cy="826920"/>
            </a:xfrm>
            <a:custGeom>
              <a:avLst/>
              <a:gdLst>
                <a:gd name="textAreaLeft" fmla="*/ 0 w 153720"/>
                <a:gd name="textAreaRight" fmla="*/ 55440 w 153720"/>
                <a:gd name="textAreaTop" fmla="*/ 3960 h 826920"/>
                <a:gd name="textAreaBottom" fmla="*/ 822960 h 826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68"/>
                    <a:pt x="10800" y="335"/>
                  </a:cubicBezTo>
                  <a:lnTo>
                    <a:pt x="10800" y="10465"/>
                  </a:lnTo>
                  <a:cubicBezTo>
                    <a:pt x="10800" y="10633"/>
                    <a:pt x="16200" y="10800"/>
                    <a:pt x="21600" y="10800"/>
                  </a:cubicBezTo>
                  <a:cubicBezTo>
                    <a:pt x="16200" y="10800"/>
                    <a:pt x="10800" y="10968"/>
                    <a:pt x="10800" y="11135"/>
                  </a:cubicBezTo>
                  <a:lnTo>
                    <a:pt x="10800" y="21265"/>
                  </a:lnTo>
                  <a:cubicBezTo>
                    <a:pt x="10800" y="21433"/>
                    <a:pt x="5400" y="21600"/>
                    <a:pt x="0" y="21600"/>
                  </a:cubicBezTo>
                </a:path>
              </a:pathLst>
            </a:cu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Rettangolo 12"/>
          <p:cNvSpPr/>
          <p:nvPr/>
        </p:nvSpPr>
        <p:spPr>
          <a:xfrm>
            <a:off x="395280" y="5253120"/>
            <a:ext cx="813744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Left Ventricular Pressure (LVP) values in rat hearts.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LVP max, indicating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ost-ischemic systolic functional recovery,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was substantially higher  in RSV group (p &lt; 0.01 </a:t>
            </a:r>
            <a:r>
              <a:rPr b="0" i="1" lang="en-GB" sz="1600" spc="-1" strike="noStrike">
                <a:solidFill>
                  <a:srgbClr val="000000"/>
                </a:solidFill>
                <a:latin typeface="Calibri"/>
              </a:rPr>
              <a:t>vs.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 I/R group, at all time-intervals), and slightly increased in AD + STN group vs. respective values in the I/R and AD groups during the second and third hour of reperfusion (p &lt; 0.05 at 90 , 120, 180 min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0-18T09:45:05Z</dcterms:created>
  <dc:creator>Pc</dc:creator>
  <dc:description/>
  <dc:language>en-US</dc:language>
  <cp:lastModifiedBy>Monica</cp:lastModifiedBy>
  <dcterms:modified xsi:type="dcterms:W3CDTF">2018-10-30T11:59:59Z</dcterms:modified>
  <cp:revision>7</cp:revision>
  <dc:subject/>
  <dc:title>Diapositiva 1</dc:title>
</cp:coreProperties>
</file>